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80" autoAdjust="0"/>
    <p:restoredTop sz="84262" autoAdjust="0"/>
  </p:normalViewPr>
  <p:slideViewPr>
    <p:cSldViewPr snapToGrid="0">
      <p:cViewPr>
        <p:scale>
          <a:sx n="99" d="100"/>
          <a:sy n="99" d="100"/>
        </p:scale>
        <p:origin x="768" y="-249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FF3DDAE-627A-47BA-8D20-ED5B77E758EC}" type="datetimeFigureOut">
              <a:rPr lang="zh-CN" altLang="en-US" smtClean="0"/>
              <a:t>2022/3/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FED3C04-8A97-401E-8FE6-143712A9A23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87704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FED3C04-8A97-401E-8FE6-143712A9A233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5416279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0A4E3B-B51B-4D84-A55B-FB05CF7D49C9}" type="datetimeFigureOut">
              <a:rPr lang="zh-CN" altLang="en-US" smtClean="0"/>
              <a:t>2022/3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8D4C1-B7DE-4610-B42E-108A7A8B98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216908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0A4E3B-B51B-4D84-A55B-FB05CF7D49C9}" type="datetimeFigureOut">
              <a:rPr lang="zh-CN" altLang="en-US" smtClean="0"/>
              <a:t>2022/3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8D4C1-B7DE-4610-B42E-108A7A8B98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80403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0A4E3B-B51B-4D84-A55B-FB05CF7D49C9}" type="datetimeFigureOut">
              <a:rPr lang="zh-CN" altLang="en-US" smtClean="0"/>
              <a:t>2022/3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8D4C1-B7DE-4610-B42E-108A7A8B98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03340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0A4E3B-B51B-4D84-A55B-FB05CF7D49C9}" type="datetimeFigureOut">
              <a:rPr lang="zh-CN" altLang="en-US" smtClean="0"/>
              <a:t>2022/3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8D4C1-B7DE-4610-B42E-108A7A8B98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78569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0A4E3B-B51B-4D84-A55B-FB05CF7D49C9}" type="datetimeFigureOut">
              <a:rPr lang="zh-CN" altLang="en-US" smtClean="0"/>
              <a:t>2022/3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8D4C1-B7DE-4610-B42E-108A7A8B98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70365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0A4E3B-B51B-4D84-A55B-FB05CF7D49C9}" type="datetimeFigureOut">
              <a:rPr lang="zh-CN" altLang="en-US" smtClean="0"/>
              <a:t>2022/3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8D4C1-B7DE-4610-B42E-108A7A8B98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68102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0A4E3B-B51B-4D84-A55B-FB05CF7D49C9}" type="datetimeFigureOut">
              <a:rPr lang="zh-CN" altLang="en-US" smtClean="0"/>
              <a:t>2022/3/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8D4C1-B7DE-4610-B42E-108A7A8B98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589718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0A4E3B-B51B-4D84-A55B-FB05CF7D49C9}" type="datetimeFigureOut">
              <a:rPr lang="zh-CN" altLang="en-US" smtClean="0"/>
              <a:t>2022/3/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8D4C1-B7DE-4610-B42E-108A7A8B98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272709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0A4E3B-B51B-4D84-A55B-FB05CF7D49C9}" type="datetimeFigureOut">
              <a:rPr lang="zh-CN" altLang="en-US" smtClean="0"/>
              <a:t>2022/3/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8D4C1-B7DE-4610-B42E-108A7A8B98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599265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0A4E3B-B51B-4D84-A55B-FB05CF7D49C9}" type="datetimeFigureOut">
              <a:rPr lang="zh-CN" altLang="en-US" smtClean="0"/>
              <a:t>2022/3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8D4C1-B7DE-4610-B42E-108A7A8B98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518193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0A4E3B-B51B-4D84-A55B-FB05CF7D49C9}" type="datetimeFigureOut">
              <a:rPr lang="zh-CN" altLang="en-US" smtClean="0"/>
              <a:t>2022/3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8D4C1-B7DE-4610-B42E-108A7A8B98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92845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0A4E3B-B51B-4D84-A55B-FB05CF7D49C9}" type="datetimeFigureOut">
              <a:rPr lang="zh-CN" altLang="en-US" smtClean="0"/>
              <a:t>2022/3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48D4C1-B7DE-4610-B42E-108A7A8B98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72004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>
            <a:extLst>
              <a:ext uri="{FF2B5EF4-FFF2-40B4-BE49-F238E27FC236}">
                <a16:creationId xmlns:a16="http://schemas.microsoft.com/office/drawing/2014/main" id="{C88C443C-59A0-4289-A80F-E85BD8131CD0}"/>
              </a:ext>
            </a:extLst>
          </p:cNvPr>
          <p:cNvGrpSpPr/>
          <p:nvPr/>
        </p:nvGrpSpPr>
        <p:grpSpPr>
          <a:xfrm>
            <a:off x="645903" y="963782"/>
            <a:ext cx="5804423" cy="7786843"/>
            <a:chOff x="523239" y="963782"/>
            <a:chExt cx="5804423" cy="7786843"/>
          </a:xfrm>
        </p:grpSpPr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id="{046F9A58-1CE0-4BD4-9C20-222E36A3B62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33054" y="6230625"/>
              <a:ext cx="2695946" cy="2520000"/>
            </a:xfrm>
            <a:prstGeom prst="rect">
              <a:avLst/>
            </a:prstGeom>
          </p:spPr>
        </p:pic>
        <p:grpSp>
          <p:nvGrpSpPr>
            <p:cNvPr id="2" name="组合 1">
              <a:extLst>
                <a:ext uri="{FF2B5EF4-FFF2-40B4-BE49-F238E27FC236}">
                  <a16:creationId xmlns:a16="http://schemas.microsoft.com/office/drawing/2014/main" id="{E98698B4-2FE8-46D0-9CDF-536D9E5F804B}"/>
                </a:ext>
              </a:extLst>
            </p:cNvPr>
            <p:cNvGrpSpPr/>
            <p:nvPr/>
          </p:nvGrpSpPr>
          <p:grpSpPr>
            <a:xfrm>
              <a:off x="523239" y="963782"/>
              <a:ext cx="5804423" cy="7786843"/>
              <a:chOff x="523239" y="963782"/>
              <a:chExt cx="5804423" cy="7786843"/>
            </a:xfrm>
          </p:grpSpPr>
          <p:pic>
            <p:nvPicPr>
              <p:cNvPr id="5" name="图片 4">
                <a:extLst>
                  <a:ext uri="{FF2B5EF4-FFF2-40B4-BE49-F238E27FC236}">
                    <a16:creationId xmlns:a16="http://schemas.microsoft.com/office/drawing/2014/main" id="{D1A7F290-C36F-4B2C-983E-0DA188E77B8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33054" y="1190625"/>
                <a:ext cx="2695946" cy="2520000"/>
              </a:xfrm>
              <a:prstGeom prst="rect">
                <a:avLst/>
              </a:prstGeom>
            </p:spPr>
          </p:pic>
          <p:pic>
            <p:nvPicPr>
              <p:cNvPr id="7" name="图片 6">
                <a:extLst>
                  <a:ext uri="{FF2B5EF4-FFF2-40B4-BE49-F238E27FC236}">
                    <a16:creationId xmlns:a16="http://schemas.microsoft.com/office/drawing/2014/main" id="{E7A55C6A-B398-4251-BABE-C670DA979A0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631716" y="1190625"/>
                <a:ext cx="2695946" cy="2520000"/>
              </a:xfrm>
              <a:prstGeom prst="rect">
                <a:avLst/>
              </a:prstGeom>
            </p:spPr>
          </p:pic>
          <p:pic>
            <p:nvPicPr>
              <p:cNvPr id="9" name="图片 8">
                <a:extLst>
                  <a:ext uri="{FF2B5EF4-FFF2-40B4-BE49-F238E27FC236}">
                    <a16:creationId xmlns:a16="http://schemas.microsoft.com/office/drawing/2014/main" id="{26C44C59-292D-4CA9-AA99-046B1F7C8A7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33054" y="3710625"/>
                <a:ext cx="2695946" cy="2520000"/>
              </a:xfrm>
              <a:prstGeom prst="rect">
                <a:avLst/>
              </a:prstGeom>
            </p:spPr>
          </p:pic>
          <p:pic>
            <p:nvPicPr>
              <p:cNvPr id="11" name="图片 10">
                <a:extLst>
                  <a:ext uri="{FF2B5EF4-FFF2-40B4-BE49-F238E27FC236}">
                    <a16:creationId xmlns:a16="http://schemas.microsoft.com/office/drawing/2014/main" id="{1164DB15-E48D-4FC3-A540-D89BBD401CB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631716" y="3710625"/>
                <a:ext cx="2693903" cy="2520000"/>
              </a:xfrm>
              <a:prstGeom prst="rect">
                <a:avLst/>
              </a:prstGeom>
            </p:spPr>
          </p:pic>
          <p:pic>
            <p:nvPicPr>
              <p:cNvPr id="15" name="图片 14">
                <a:extLst>
                  <a:ext uri="{FF2B5EF4-FFF2-40B4-BE49-F238E27FC236}">
                    <a16:creationId xmlns:a16="http://schemas.microsoft.com/office/drawing/2014/main" id="{C1DE14F5-7769-4CED-90EA-909529C08E0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629673" y="6230625"/>
                <a:ext cx="2693903" cy="2520000"/>
              </a:xfrm>
              <a:prstGeom prst="rect">
                <a:avLst/>
              </a:prstGeom>
            </p:spPr>
          </p:pic>
          <p:sp>
            <p:nvSpPr>
              <p:cNvPr id="17" name="文本框 16">
                <a:extLst>
                  <a:ext uri="{FF2B5EF4-FFF2-40B4-BE49-F238E27FC236}">
                    <a16:creationId xmlns:a16="http://schemas.microsoft.com/office/drawing/2014/main" id="{C94F08C2-3D73-43B4-8515-3D9F4426AFC5}"/>
                  </a:ext>
                </a:extLst>
              </p:cNvPr>
              <p:cNvSpPr txBox="1"/>
              <p:nvPr/>
            </p:nvSpPr>
            <p:spPr>
              <a:xfrm>
                <a:off x="523239" y="963782"/>
                <a:ext cx="326004" cy="3694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914400"/>
                <a:r>
                  <a:rPr lang="en-US" altLang="zh-CN" sz="180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zh-CN" altLang="en-US" sz="180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id="{8DA7FAE5-E148-4BF8-BEF5-2912F6602AED}"/>
                  </a:ext>
                </a:extLst>
              </p:cNvPr>
              <p:cNvSpPr txBox="1"/>
              <p:nvPr/>
            </p:nvSpPr>
            <p:spPr>
              <a:xfrm>
                <a:off x="3428674" y="971155"/>
                <a:ext cx="326004" cy="3694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914400"/>
                <a:r>
                  <a:rPr lang="en-US" altLang="zh-CN" sz="180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  <a:endParaRPr lang="zh-CN" altLang="en-US" sz="180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文本框 18">
                <a:extLst>
                  <a:ext uri="{FF2B5EF4-FFF2-40B4-BE49-F238E27FC236}">
                    <a16:creationId xmlns:a16="http://schemas.microsoft.com/office/drawing/2014/main" id="{365088F2-4DF9-4844-B6CD-0CCB7277634C}"/>
                  </a:ext>
                </a:extLst>
              </p:cNvPr>
              <p:cNvSpPr txBox="1"/>
              <p:nvPr/>
            </p:nvSpPr>
            <p:spPr>
              <a:xfrm>
                <a:off x="545362" y="3485765"/>
                <a:ext cx="326004" cy="3694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914400"/>
                <a:r>
                  <a:rPr lang="en-US" altLang="zh-CN" sz="180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zh-CN" altLang="en-US" sz="180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文本框 20">
                <a:extLst>
                  <a:ext uri="{FF2B5EF4-FFF2-40B4-BE49-F238E27FC236}">
                    <a16:creationId xmlns:a16="http://schemas.microsoft.com/office/drawing/2014/main" id="{E927DC08-6521-4F1E-BABD-4D2098C299BD}"/>
                  </a:ext>
                </a:extLst>
              </p:cNvPr>
              <p:cNvSpPr txBox="1"/>
              <p:nvPr/>
            </p:nvSpPr>
            <p:spPr>
              <a:xfrm>
                <a:off x="3465547" y="3493139"/>
                <a:ext cx="326004" cy="3694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914400"/>
                <a:r>
                  <a:rPr lang="en-US" altLang="zh-CN" sz="180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</a:t>
                </a:r>
                <a:endParaRPr lang="zh-CN" altLang="en-US" sz="180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文本框 21">
                <a:extLst>
                  <a:ext uri="{FF2B5EF4-FFF2-40B4-BE49-F238E27FC236}">
                    <a16:creationId xmlns:a16="http://schemas.microsoft.com/office/drawing/2014/main" id="{68BA873B-217A-4874-B818-55EE68179B4D}"/>
                  </a:ext>
                </a:extLst>
              </p:cNvPr>
              <p:cNvSpPr txBox="1"/>
              <p:nvPr/>
            </p:nvSpPr>
            <p:spPr>
              <a:xfrm>
                <a:off x="545359" y="6015113"/>
                <a:ext cx="326004" cy="3694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914400"/>
                <a:r>
                  <a:rPr lang="en-US" altLang="zh-CN" sz="180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zh-CN" altLang="en-US" sz="180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文本框 22">
                <a:extLst>
                  <a:ext uri="{FF2B5EF4-FFF2-40B4-BE49-F238E27FC236}">
                    <a16:creationId xmlns:a16="http://schemas.microsoft.com/office/drawing/2014/main" id="{845D2765-06BE-4305-9EBA-253C5EF40174}"/>
                  </a:ext>
                </a:extLst>
              </p:cNvPr>
              <p:cNvSpPr txBox="1"/>
              <p:nvPr/>
            </p:nvSpPr>
            <p:spPr>
              <a:xfrm>
                <a:off x="3470460" y="5997907"/>
                <a:ext cx="326004" cy="3694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914400"/>
                <a:r>
                  <a:rPr lang="en-US" altLang="zh-CN" sz="180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</a:t>
                </a:r>
                <a:endParaRPr lang="zh-CN" altLang="en-US" sz="180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20" name="文本框 19">
            <a:extLst>
              <a:ext uri="{FF2B5EF4-FFF2-40B4-BE49-F238E27FC236}">
                <a16:creationId xmlns:a16="http://schemas.microsoft.com/office/drawing/2014/main" id="{CCE4CE7C-1DE6-4191-97DD-91195162444E}"/>
              </a:ext>
            </a:extLst>
          </p:cNvPr>
          <p:cNvSpPr txBox="1"/>
          <p:nvPr/>
        </p:nvSpPr>
        <p:spPr>
          <a:xfrm>
            <a:off x="195666" y="342286"/>
            <a:ext cx="145490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FIGURE S1</a:t>
            </a:r>
            <a:endParaRPr lang="zh-CN" altLang="en-US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2B10A3F7-3598-4C71-86F1-A96A6CBB97FD}"/>
              </a:ext>
            </a:extLst>
          </p:cNvPr>
          <p:cNvSpPr txBox="1"/>
          <p:nvPr/>
        </p:nvSpPr>
        <p:spPr>
          <a:xfrm>
            <a:off x="185980" y="8849988"/>
            <a:ext cx="657128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 S1. Decision curve analyses (DCA) of nomogram prediction model and model without DR category for 1,2,3-year OS in the training cohort (A-C), and the validation cohort (D-F) </a:t>
            </a:r>
          </a:p>
        </p:txBody>
      </p:sp>
    </p:spTree>
    <p:extLst>
      <p:ext uri="{BB962C8B-B14F-4D97-AF65-F5344CB8AC3E}">
        <p14:creationId xmlns:p14="http://schemas.microsoft.com/office/powerpoint/2010/main" val="14225814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</TotalTime>
  <Words>44</Words>
  <Application>Microsoft Office PowerPoint</Application>
  <PresentationFormat>A4 纸张(210x297 毫米)</PresentationFormat>
  <Paragraphs>9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qin xs</dc:creator>
  <cp:lastModifiedBy>qin xs</cp:lastModifiedBy>
  <cp:revision>7</cp:revision>
  <dcterms:created xsi:type="dcterms:W3CDTF">2022-02-10T14:45:10Z</dcterms:created>
  <dcterms:modified xsi:type="dcterms:W3CDTF">2022-03-01T06:19:32Z</dcterms:modified>
</cp:coreProperties>
</file>